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293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382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21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628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388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873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554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261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988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941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117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631D7-49F2-4B37-8D9D-1F03ED52F3D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8C5A9-F805-4D85-A33B-F77E3CB006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98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8206" y="487248"/>
            <a:ext cx="9160827" cy="5429727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897466" y="591697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5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nM) for reversed chloroquinolines against resistant strain 7G8.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2805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8:46Z</dcterms:created>
  <dcterms:modified xsi:type="dcterms:W3CDTF">2020-08-04T16:33:54Z</dcterms:modified>
</cp:coreProperties>
</file>